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9144000" cy="5486400"/>
  <p:notesSz cx="6858000" cy="9144000"/>
  <p:defaultTextStyle>
    <a:defPPr>
      <a:defRPr lang="en-US"/>
    </a:defPPr>
    <a:lvl1pPr marL="0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1pPr>
    <a:lvl2pPr marL="365733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2pPr>
    <a:lvl3pPr marL="731465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3pPr>
    <a:lvl4pPr marL="1097198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4pPr>
    <a:lvl5pPr marL="1462930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5pPr>
    <a:lvl6pPr marL="1828663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6pPr>
    <a:lvl7pPr marL="2194395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7pPr>
    <a:lvl8pPr marL="2560128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8pPr>
    <a:lvl9pPr marL="2925861" algn="l" defTabSz="731465" rtl="0" eaLnBrk="1" latinLnBrk="0" hangingPunct="1">
      <a:defRPr sz="144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28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08" y="480"/>
      </p:cViewPr>
      <p:guideLst>
        <p:guide orient="horz" pos="1728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704340"/>
            <a:ext cx="7772400" cy="117602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2" y="3108960"/>
            <a:ext cx="6400800" cy="14020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2712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5424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8136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0848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3560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6272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18984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1696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19711"/>
            <a:ext cx="2057400" cy="468122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19711"/>
            <a:ext cx="6019800" cy="468122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2" y="3525519"/>
            <a:ext cx="7772400" cy="1089660"/>
          </a:xfrm>
        </p:spPr>
        <p:txBody>
          <a:bodyPr anchor="t"/>
          <a:lstStyle>
            <a:lvl1pPr algn="l">
              <a:defRPr sz="2373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2" y="2325373"/>
            <a:ext cx="7772400" cy="1200150"/>
          </a:xfrm>
        </p:spPr>
        <p:txBody>
          <a:bodyPr anchor="b"/>
          <a:lstStyle>
            <a:lvl1pPr marL="0" indent="0">
              <a:buNone/>
              <a:defRPr sz="1185">
                <a:solidFill>
                  <a:schemeClr val="tx1">
                    <a:tint val="75000"/>
                  </a:schemeClr>
                </a:solidFill>
              </a:defRPr>
            </a:lvl1pPr>
            <a:lvl2pPr marL="271211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2pPr>
            <a:lvl3pPr marL="542421" indent="0">
              <a:buNone/>
              <a:defRPr sz="948">
                <a:solidFill>
                  <a:schemeClr val="tx1">
                    <a:tint val="75000"/>
                  </a:schemeClr>
                </a:solidFill>
              </a:defRPr>
            </a:lvl3pPr>
            <a:lvl4pPr marL="813633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4pPr>
            <a:lvl5pPr marL="1084844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5pPr>
            <a:lvl6pPr marL="1356055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6pPr>
            <a:lvl7pPr marL="1627265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7pPr>
            <a:lvl8pPr marL="1898478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8pPr>
            <a:lvl9pPr marL="2169686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280163"/>
            <a:ext cx="4038600" cy="3620769"/>
          </a:xfrm>
        </p:spPr>
        <p:txBody>
          <a:bodyPr/>
          <a:lstStyle>
            <a:lvl1pPr>
              <a:defRPr sz="1662"/>
            </a:lvl1pPr>
            <a:lvl2pPr>
              <a:defRPr sz="1423"/>
            </a:lvl2pPr>
            <a:lvl3pPr>
              <a:defRPr sz="1185"/>
            </a:lvl3pPr>
            <a:lvl4pPr>
              <a:defRPr sz="1067"/>
            </a:lvl4pPr>
            <a:lvl5pPr>
              <a:defRPr sz="1067"/>
            </a:lvl5pPr>
            <a:lvl6pPr>
              <a:defRPr sz="1067"/>
            </a:lvl6pPr>
            <a:lvl7pPr>
              <a:defRPr sz="1067"/>
            </a:lvl7pPr>
            <a:lvl8pPr>
              <a:defRPr sz="1067"/>
            </a:lvl8pPr>
            <a:lvl9pPr>
              <a:defRPr sz="10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280163"/>
            <a:ext cx="4038600" cy="3620769"/>
          </a:xfrm>
        </p:spPr>
        <p:txBody>
          <a:bodyPr/>
          <a:lstStyle>
            <a:lvl1pPr>
              <a:defRPr sz="1662"/>
            </a:lvl1pPr>
            <a:lvl2pPr>
              <a:defRPr sz="1423"/>
            </a:lvl2pPr>
            <a:lvl3pPr>
              <a:defRPr sz="1185"/>
            </a:lvl3pPr>
            <a:lvl4pPr>
              <a:defRPr sz="1067"/>
            </a:lvl4pPr>
            <a:lvl5pPr>
              <a:defRPr sz="1067"/>
            </a:lvl5pPr>
            <a:lvl6pPr>
              <a:defRPr sz="1067"/>
            </a:lvl6pPr>
            <a:lvl7pPr>
              <a:defRPr sz="1067"/>
            </a:lvl7pPr>
            <a:lvl8pPr>
              <a:defRPr sz="1067"/>
            </a:lvl8pPr>
            <a:lvl9pPr>
              <a:defRPr sz="10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28091"/>
            <a:ext cx="4040189" cy="511809"/>
          </a:xfrm>
        </p:spPr>
        <p:txBody>
          <a:bodyPr anchor="b"/>
          <a:lstStyle>
            <a:lvl1pPr marL="0" indent="0">
              <a:buNone/>
              <a:defRPr sz="1423" b="1"/>
            </a:lvl1pPr>
            <a:lvl2pPr marL="271211" indent="0">
              <a:buNone/>
              <a:defRPr sz="1185" b="1"/>
            </a:lvl2pPr>
            <a:lvl3pPr marL="542421" indent="0">
              <a:buNone/>
              <a:defRPr sz="1067" b="1"/>
            </a:lvl3pPr>
            <a:lvl4pPr marL="813633" indent="0">
              <a:buNone/>
              <a:defRPr sz="948" b="1"/>
            </a:lvl4pPr>
            <a:lvl5pPr marL="1084844" indent="0">
              <a:buNone/>
              <a:defRPr sz="948" b="1"/>
            </a:lvl5pPr>
            <a:lvl6pPr marL="1356055" indent="0">
              <a:buNone/>
              <a:defRPr sz="948" b="1"/>
            </a:lvl6pPr>
            <a:lvl7pPr marL="1627265" indent="0">
              <a:buNone/>
              <a:defRPr sz="948" b="1"/>
            </a:lvl7pPr>
            <a:lvl8pPr marL="1898478" indent="0">
              <a:buNone/>
              <a:defRPr sz="948" b="1"/>
            </a:lvl8pPr>
            <a:lvl9pPr marL="2169686" indent="0">
              <a:buNone/>
              <a:defRPr sz="94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739903"/>
            <a:ext cx="4040189" cy="3161031"/>
          </a:xfrm>
        </p:spPr>
        <p:txBody>
          <a:bodyPr/>
          <a:lstStyle>
            <a:lvl1pPr>
              <a:defRPr sz="1423"/>
            </a:lvl1pPr>
            <a:lvl2pPr>
              <a:defRPr sz="1185"/>
            </a:lvl2pPr>
            <a:lvl3pPr>
              <a:defRPr sz="1067"/>
            </a:lvl3pPr>
            <a:lvl4pPr>
              <a:defRPr sz="948"/>
            </a:lvl4pPr>
            <a:lvl5pPr>
              <a:defRPr sz="948"/>
            </a:lvl5pPr>
            <a:lvl6pPr>
              <a:defRPr sz="948"/>
            </a:lvl6pPr>
            <a:lvl7pPr>
              <a:defRPr sz="948"/>
            </a:lvl7pPr>
            <a:lvl8pPr>
              <a:defRPr sz="948"/>
            </a:lvl8pPr>
            <a:lvl9pPr>
              <a:defRPr sz="948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1228091"/>
            <a:ext cx="4041774" cy="511809"/>
          </a:xfrm>
        </p:spPr>
        <p:txBody>
          <a:bodyPr anchor="b"/>
          <a:lstStyle>
            <a:lvl1pPr marL="0" indent="0">
              <a:buNone/>
              <a:defRPr sz="1423" b="1"/>
            </a:lvl1pPr>
            <a:lvl2pPr marL="271211" indent="0">
              <a:buNone/>
              <a:defRPr sz="1185" b="1"/>
            </a:lvl2pPr>
            <a:lvl3pPr marL="542421" indent="0">
              <a:buNone/>
              <a:defRPr sz="1067" b="1"/>
            </a:lvl3pPr>
            <a:lvl4pPr marL="813633" indent="0">
              <a:buNone/>
              <a:defRPr sz="948" b="1"/>
            </a:lvl4pPr>
            <a:lvl5pPr marL="1084844" indent="0">
              <a:buNone/>
              <a:defRPr sz="948" b="1"/>
            </a:lvl5pPr>
            <a:lvl6pPr marL="1356055" indent="0">
              <a:buNone/>
              <a:defRPr sz="948" b="1"/>
            </a:lvl6pPr>
            <a:lvl7pPr marL="1627265" indent="0">
              <a:buNone/>
              <a:defRPr sz="948" b="1"/>
            </a:lvl7pPr>
            <a:lvl8pPr marL="1898478" indent="0">
              <a:buNone/>
              <a:defRPr sz="948" b="1"/>
            </a:lvl8pPr>
            <a:lvl9pPr marL="2169686" indent="0">
              <a:buNone/>
              <a:defRPr sz="948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1739903"/>
            <a:ext cx="4041774" cy="3161031"/>
          </a:xfrm>
        </p:spPr>
        <p:txBody>
          <a:bodyPr/>
          <a:lstStyle>
            <a:lvl1pPr>
              <a:defRPr sz="1423"/>
            </a:lvl1pPr>
            <a:lvl2pPr>
              <a:defRPr sz="1185"/>
            </a:lvl2pPr>
            <a:lvl3pPr>
              <a:defRPr sz="1067"/>
            </a:lvl3pPr>
            <a:lvl4pPr>
              <a:defRPr sz="948"/>
            </a:lvl4pPr>
            <a:lvl5pPr>
              <a:defRPr sz="948"/>
            </a:lvl5pPr>
            <a:lvl6pPr>
              <a:defRPr sz="948"/>
            </a:lvl6pPr>
            <a:lvl7pPr>
              <a:defRPr sz="948"/>
            </a:lvl7pPr>
            <a:lvl8pPr>
              <a:defRPr sz="948"/>
            </a:lvl8pPr>
            <a:lvl9pPr>
              <a:defRPr sz="948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18439"/>
            <a:ext cx="3008313" cy="929640"/>
          </a:xfrm>
        </p:spPr>
        <p:txBody>
          <a:bodyPr anchor="b"/>
          <a:lstStyle>
            <a:lvl1pPr algn="l">
              <a:defRPr sz="1185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3" y="218442"/>
            <a:ext cx="5111750" cy="4682490"/>
          </a:xfrm>
        </p:spPr>
        <p:txBody>
          <a:bodyPr/>
          <a:lstStyle>
            <a:lvl1pPr>
              <a:defRPr sz="1897"/>
            </a:lvl1pPr>
            <a:lvl2pPr>
              <a:defRPr sz="1662"/>
            </a:lvl2pPr>
            <a:lvl3pPr>
              <a:defRPr sz="1423"/>
            </a:lvl3pPr>
            <a:lvl4pPr>
              <a:defRPr sz="1185"/>
            </a:lvl4pPr>
            <a:lvl5pPr>
              <a:defRPr sz="1185"/>
            </a:lvl5pPr>
            <a:lvl6pPr>
              <a:defRPr sz="1185"/>
            </a:lvl6pPr>
            <a:lvl7pPr>
              <a:defRPr sz="1185"/>
            </a:lvl7pPr>
            <a:lvl8pPr>
              <a:defRPr sz="1185"/>
            </a:lvl8pPr>
            <a:lvl9pPr>
              <a:defRPr sz="1185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148083"/>
            <a:ext cx="3008313" cy="3752850"/>
          </a:xfrm>
        </p:spPr>
        <p:txBody>
          <a:bodyPr/>
          <a:lstStyle>
            <a:lvl1pPr marL="0" indent="0">
              <a:buNone/>
              <a:defRPr sz="831"/>
            </a:lvl1pPr>
            <a:lvl2pPr marL="271211" indent="0">
              <a:buNone/>
              <a:defRPr sz="710"/>
            </a:lvl2pPr>
            <a:lvl3pPr marL="542421" indent="0">
              <a:buNone/>
              <a:defRPr sz="593"/>
            </a:lvl3pPr>
            <a:lvl4pPr marL="813633" indent="0">
              <a:buNone/>
              <a:defRPr sz="534"/>
            </a:lvl4pPr>
            <a:lvl5pPr marL="1084844" indent="0">
              <a:buNone/>
              <a:defRPr sz="534"/>
            </a:lvl5pPr>
            <a:lvl6pPr marL="1356055" indent="0">
              <a:buNone/>
              <a:defRPr sz="534"/>
            </a:lvl6pPr>
            <a:lvl7pPr marL="1627265" indent="0">
              <a:buNone/>
              <a:defRPr sz="534"/>
            </a:lvl7pPr>
            <a:lvl8pPr marL="1898478" indent="0">
              <a:buNone/>
              <a:defRPr sz="534"/>
            </a:lvl8pPr>
            <a:lvl9pPr marL="2169686" indent="0">
              <a:buNone/>
              <a:defRPr sz="53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9" y="3840482"/>
            <a:ext cx="5486400" cy="453390"/>
          </a:xfrm>
        </p:spPr>
        <p:txBody>
          <a:bodyPr anchor="b"/>
          <a:lstStyle>
            <a:lvl1pPr algn="l">
              <a:defRPr sz="1185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9" y="490221"/>
            <a:ext cx="5486400" cy="3291840"/>
          </a:xfrm>
        </p:spPr>
        <p:txBody>
          <a:bodyPr/>
          <a:lstStyle>
            <a:lvl1pPr marL="0" indent="0">
              <a:buNone/>
              <a:defRPr sz="1897"/>
            </a:lvl1pPr>
            <a:lvl2pPr marL="271211" indent="0">
              <a:buNone/>
              <a:defRPr sz="1662"/>
            </a:lvl2pPr>
            <a:lvl3pPr marL="542421" indent="0">
              <a:buNone/>
              <a:defRPr sz="1423"/>
            </a:lvl3pPr>
            <a:lvl4pPr marL="813633" indent="0">
              <a:buNone/>
              <a:defRPr sz="1185"/>
            </a:lvl4pPr>
            <a:lvl5pPr marL="1084844" indent="0">
              <a:buNone/>
              <a:defRPr sz="1185"/>
            </a:lvl5pPr>
            <a:lvl6pPr marL="1356055" indent="0">
              <a:buNone/>
              <a:defRPr sz="1185"/>
            </a:lvl6pPr>
            <a:lvl7pPr marL="1627265" indent="0">
              <a:buNone/>
              <a:defRPr sz="1185"/>
            </a:lvl7pPr>
            <a:lvl8pPr marL="1898478" indent="0">
              <a:buNone/>
              <a:defRPr sz="1185"/>
            </a:lvl8pPr>
            <a:lvl9pPr marL="2169686" indent="0">
              <a:buNone/>
              <a:defRPr sz="1185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9" y="4293872"/>
            <a:ext cx="5486400" cy="643890"/>
          </a:xfrm>
        </p:spPr>
        <p:txBody>
          <a:bodyPr/>
          <a:lstStyle>
            <a:lvl1pPr marL="0" indent="0">
              <a:buNone/>
              <a:defRPr sz="831"/>
            </a:lvl1pPr>
            <a:lvl2pPr marL="271211" indent="0">
              <a:buNone/>
              <a:defRPr sz="710"/>
            </a:lvl2pPr>
            <a:lvl3pPr marL="542421" indent="0">
              <a:buNone/>
              <a:defRPr sz="593"/>
            </a:lvl3pPr>
            <a:lvl4pPr marL="813633" indent="0">
              <a:buNone/>
              <a:defRPr sz="534"/>
            </a:lvl4pPr>
            <a:lvl5pPr marL="1084844" indent="0">
              <a:buNone/>
              <a:defRPr sz="534"/>
            </a:lvl5pPr>
            <a:lvl6pPr marL="1356055" indent="0">
              <a:buNone/>
              <a:defRPr sz="534"/>
            </a:lvl6pPr>
            <a:lvl7pPr marL="1627265" indent="0">
              <a:buNone/>
              <a:defRPr sz="534"/>
            </a:lvl7pPr>
            <a:lvl8pPr marL="1898478" indent="0">
              <a:buNone/>
              <a:defRPr sz="534"/>
            </a:lvl8pPr>
            <a:lvl9pPr marL="2169686" indent="0">
              <a:buNone/>
              <a:defRPr sz="534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19711"/>
            <a:ext cx="8229600" cy="914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280163"/>
            <a:ext cx="8229600" cy="36207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5085080"/>
            <a:ext cx="2133600" cy="2921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0/2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2" y="5085080"/>
            <a:ext cx="2895600" cy="2921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5085080"/>
            <a:ext cx="2133600" cy="2921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1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542421" rtl="0" eaLnBrk="1" latinLnBrk="0" hangingPunct="1">
        <a:spcBef>
          <a:spcPct val="0"/>
        </a:spcBef>
        <a:buNone/>
        <a:defRPr sz="26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3408" indent="-203408" algn="l" defTabSz="542421" rtl="0" eaLnBrk="1" latinLnBrk="0" hangingPunct="1">
        <a:spcBef>
          <a:spcPct val="20000"/>
        </a:spcBef>
        <a:buFont typeface="Arial" pitchFamily="34" charset="0"/>
        <a:buChar char="•"/>
        <a:defRPr sz="1897" kern="1200">
          <a:solidFill>
            <a:schemeClr val="tx1"/>
          </a:solidFill>
          <a:latin typeface="+mn-lt"/>
          <a:ea typeface="+mn-ea"/>
          <a:cs typeface="+mn-cs"/>
        </a:defRPr>
      </a:lvl1pPr>
      <a:lvl2pPr marL="440718" indent="-169507" algn="l" defTabSz="542421" rtl="0" eaLnBrk="1" latinLnBrk="0" hangingPunct="1">
        <a:spcBef>
          <a:spcPct val="20000"/>
        </a:spcBef>
        <a:buFont typeface="Arial" pitchFamily="34" charset="0"/>
        <a:buChar char="–"/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678027" indent="-135606" algn="l" defTabSz="542421" rtl="0" eaLnBrk="1" latinLnBrk="0" hangingPunct="1">
        <a:spcBef>
          <a:spcPct val="20000"/>
        </a:spcBef>
        <a:buFont typeface="Arial" pitchFamily="34" charset="0"/>
        <a:buChar char="•"/>
        <a:defRPr sz="1423" kern="1200">
          <a:solidFill>
            <a:schemeClr val="tx1"/>
          </a:solidFill>
          <a:latin typeface="+mn-lt"/>
          <a:ea typeface="+mn-ea"/>
          <a:cs typeface="+mn-cs"/>
        </a:defRPr>
      </a:lvl3pPr>
      <a:lvl4pPr marL="949238" indent="-135606" algn="l" defTabSz="542421" rtl="0" eaLnBrk="1" latinLnBrk="0" hangingPunct="1">
        <a:spcBef>
          <a:spcPct val="20000"/>
        </a:spcBef>
        <a:buFont typeface="Arial" pitchFamily="34" charset="0"/>
        <a:buChar char="–"/>
        <a:defRPr sz="1185" kern="1200">
          <a:solidFill>
            <a:schemeClr val="tx1"/>
          </a:solidFill>
          <a:latin typeface="+mn-lt"/>
          <a:ea typeface="+mn-ea"/>
          <a:cs typeface="+mn-cs"/>
        </a:defRPr>
      </a:lvl4pPr>
      <a:lvl5pPr marL="1220451" indent="-135606" algn="l" defTabSz="542421" rtl="0" eaLnBrk="1" latinLnBrk="0" hangingPunct="1">
        <a:spcBef>
          <a:spcPct val="20000"/>
        </a:spcBef>
        <a:buFont typeface="Arial" pitchFamily="34" charset="0"/>
        <a:buChar char="»"/>
        <a:defRPr sz="1185" kern="1200">
          <a:solidFill>
            <a:schemeClr val="tx1"/>
          </a:solidFill>
          <a:latin typeface="+mn-lt"/>
          <a:ea typeface="+mn-ea"/>
          <a:cs typeface="+mn-cs"/>
        </a:defRPr>
      </a:lvl5pPr>
      <a:lvl6pPr marL="1491659" indent="-135606" algn="l" defTabSz="542421" rtl="0" eaLnBrk="1" latinLnBrk="0" hangingPunct="1">
        <a:spcBef>
          <a:spcPct val="20000"/>
        </a:spcBef>
        <a:buFont typeface="Arial" pitchFamily="34" charset="0"/>
        <a:buChar char="•"/>
        <a:defRPr sz="1185" kern="1200">
          <a:solidFill>
            <a:schemeClr val="tx1"/>
          </a:solidFill>
          <a:latin typeface="+mn-lt"/>
          <a:ea typeface="+mn-ea"/>
          <a:cs typeface="+mn-cs"/>
        </a:defRPr>
      </a:lvl6pPr>
      <a:lvl7pPr marL="1762871" indent="-135606" algn="l" defTabSz="542421" rtl="0" eaLnBrk="1" latinLnBrk="0" hangingPunct="1">
        <a:spcBef>
          <a:spcPct val="20000"/>
        </a:spcBef>
        <a:buFont typeface="Arial" pitchFamily="34" charset="0"/>
        <a:buChar char="•"/>
        <a:defRPr sz="1185" kern="1200">
          <a:solidFill>
            <a:schemeClr val="tx1"/>
          </a:solidFill>
          <a:latin typeface="+mn-lt"/>
          <a:ea typeface="+mn-ea"/>
          <a:cs typeface="+mn-cs"/>
        </a:defRPr>
      </a:lvl7pPr>
      <a:lvl8pPr marL="2034082" indent="-135606" algn="l" defTabSz="542421" rtl="0" eaLnBrk="1" latinLnBrk="0" hangingPunct="1">
        <a:spcBef>
          <a:spcPct val="20000"/>
        </a:spcBef>
        <a:buFont typeface="Arial" pitchFamily="34" charset="0"/>
        <a:buChar char="•"/>
        <a:defRPr sz="1185" kern="1200">
          <a:solidFill>
            <a:schemeClr val="tx1"/>
          </a:solidFill>
          <a:latin typeface="+mn-lt"/>
          <a:ea typeface="+mn-ea"/>
          <a:cs typeface="+mn-cs"/>
        </a:defRPr>
      </a:lvl8pPr>
      <a:lvl9pPr marL="2305292" indent="-135606" algn="l" defTabSz="542421" rtl="0" eaLnBrk="1" latinLnBrk="0" hangingPunct="1">
        <a:spcBef>
          <a:spcPct val="20000"/>
        </a:spcBef>
        <a:buFont typeface="Arial" pitchFamily="34" charset="0"/>
        <a:buChar char="•"/>
        <a:defRPr sz="11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1pPr>
      <a:lvl2pPr marL="271211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2pPr>
      <a:lvl3pPr marL="542421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3pPr>
      <a:lvl4pPr marL="813633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4pPr>
      <a:lvl5pPr marL="1084844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5pPr>
      <a:lvl6pPr marL="1356055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6pPr>
      <a:lvl7pPr marL="1627265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7pPr>
      <a:lvl8pPr marL="1898478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8pPr>
      <a:lvl9pPr marL="2169686" algn="l" defTabSz="542421" rtl="0" eaLnBrk="1" latinLnBrk="0" hangingPunct="1">
        <a:defRPr sz="10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756" y="520020"/>
            <a:ext cx="8822283" cy="426338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9" name="Rectangle 8"/>
          <p:cNvSpPr/>
          <p:nvPr/>
        </p:nvSpPr>
        <p:spPr>
          <a:xfrm>
            <a:off x="3898909" y="269270"/>
            <a:ext cx="575799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R: C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993131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381000"/>
            <a:ext cx="8803794" cy="4267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/>
          <p:cNvSpPr/>
          <p:nvPr/>
        </p:nvSpPr>
        <p:spPr>
          <a:xfrm>
            <a:off x="37809" y="4695338"/>
            <a:ext cx="89916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ample peak of mass spectrometry analysis (HPLC/MS, Agilent 1,200 series, Agilent Technologies) of leaf samples from the white-mold-resistant (R) line SCNU-C-049 (1-5) and -susceptible (S) line SCNU-C-033 (6-10) of cabbage under different treatment conditions (C, control; M1, mock day 1; T1, treated day 1; M3, mock day 3; T3, treated day 3) was used to identify individual GSLs. </a:t>
            </a:r>
          </a:p>
        </p:txBody>
      </p:sp>
      <p:sp>
        <p:nvSpPr>
          <p:cNvPr id="7" name="Rectangle 6"/>
          <p:cNvSpPr/>
          <p:nvPr/>
        </p:nvSpPr>
        <p:spPr>
          <a:xfrm>
            <a:off x="3864685" y="103515"/>
            <a:ext cx="689612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 S: T3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33094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621116"/>
            <a:ext cx="8879117" cy="4267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898909" y="353055"/>
            <a:ext cx="675185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R: M1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482396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685800"/>
            <a:ext cx="8841003" cy="4267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898909" y="353055"/>
            <a:ext cx="636713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R: T1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7364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760" y="654948"/>
            <a:ext cx="8786045" cy="4267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3898909" y="353055"/>
            <a:ext cx="675185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R: M3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36376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734055"/>
            <a:ext cx="8931767" cy="43434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</p:pic>
      <p:sp>
        <p:nvSpPr>
          <p:cNvPr id="9" name="Rectangle 8"/>
          <p:cNvSpPr/>
          <p:nvPr/>
        </p:nvSpPr>
        <p:spPr>
          <a:xfrm>
            <a:off x="3898909" y="353055"/>
            <a:ext cx="636713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R: T3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64047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399" y="553735"/>
            <a:ext cx="8811209" cy="4267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/>
          <p:cNvSpPr/>
          <p:nvPr/>
        </p:nvSpPr>
        <p:spPr>
          <a:xfrm>
            <a:off x="3898909" y="269270"/>
            <a:ext cx="559769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S: </a:t>
            </a:r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50634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589564"/>
            <a:ext cx="8852577" cy="42872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Rectangle 5"/>
          <p:cNvSpPr/>
          <p:nvPr/>
        </p:nvSpPr>
        <p:spPr>
          <a:xfrm>
            <a:off x="3790568" y="228600"/>
            <a:ext cx="659155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 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S: </a:t>
            </a:r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1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31020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99" y="457200"/>
            <a:ext cx="8991283" cy="4343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tangle 4"/>
          <p:cNvSpPr/>
          <p:nvPr/>
        </p:nvSpPr>
        <p:spPr>
          <a:xfrm>
            <a:off x="3740780" y="151795"/>
            <a:ext cx="620683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. 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S: </a:t>
            </a:r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1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43522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381000"/>
            <a:ext cx="8811208" cy="4267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Rectangle 4"/>
          <p:cNvSpPr/>
          <p:nvPr/>
        </p:nvSpPr>
        <p:spPr>
          <a:xfrm>
            <a:off x="3810000" y="80248"/>
            <a:ext cx="659155" cy="25654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 </a:t>
            </a:r>
            <a:r>
              <a:rPr lang="en-US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S: </a:t>
            </a:r>
            <a:r>
              <a:rPr lang="en-US" sz="1067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3</a:t>
            </a:r>
            <a:endParaRPr 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5418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9</TotalTime>
  <Words>137</Words>
  <Application>Microsoft Office PowerPoint</Application>
  <PresentationFormat>Custom</PresentationFormat>
  <Paragraphs>11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suf</dc:creator>
  <cp:lastModifiedBy>user</cp:lastModifiedBy>
  <cp:revision>10</cp:revision>
  <dcterms:created xsi:type="dcterms:W3CDTF">2006-08-16T00:00:00Z</dcterms:created>
  <dcterms:modified xsi:type="dcterms:W3CDTF">2018-10-24T17:19:29Z</dcterms:modified>
</cp:coreProperties>
</file>